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4D188-EC69-4F49-B083-38A4013CB1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A9787-D5CF-4490-AAB2-6140B6A9FE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11D98-7198-4E0C-AB77-38B7A2341E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1B7986-8211-4DF4-9B3B-462C29843F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7CC7D-3445-43DE-90F6-1579796422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5697E-037A-4FF0-BF8F-EDE8CE3B68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B7D28-D4AF-49D1-B808-B174861B60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7D9A7-126F-46C7-990D-47CDB403D4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865B0-5381-4FD9-BE7C-7285D2EB74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EB9DB-0B90-4E84-858F-1092EC8F1D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C0EB0-92B7-47E8-A3C9-081E94413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9B3FC-8BFB-43C7-9B3F-6BAA9AB83D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E7F1B2-B205-4B6A-8C78-4815C2DE0B2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04720" y="2124000"/>
          <a:ext cx="5848560" cy="2765520"/>
        </p:xfrm>
        <a:graphic>
          <a:graphicData uri="http://schemas.openxmlformats.org/drawingml/2006/table">
            <a:tbl>
              <a:tblPr/>
              <a:tblGrid>
                <a:gridCol w="835200"/>
                <a:gridCol w="834840"/>
                <a:gridCol w="836640"/>
                <a:gridCol w="835200"/>
                <a:gridCol w="836640"/>
                <a:gridCol w="834840"/>
                <a:gridCol w="835200"/>
              </a:tblGrid>
              <a:tr h="5032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Number of 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Number of 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Number of 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ycl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7542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yclin 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75384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urviv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7542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urvivin 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4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°C: 20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°C: 15 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42" name="ZoneTexte 4"/>
          <p:cNvSpPr/>
          <p:nvPr/>
        </p:nvSpPr>
        <p:spPr>
          <a:xfrm>
            <a:off x="569880" y="5435640"/>
            <a:ext cx="375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1: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PCR conditions for 5’RACE analysi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4T14:46:08Z</dcterms:created>
  <dc:creator>Valerie KEDINGER</dc:creator>
  <dc:description/>
  <dc:language>en-US</dc:language>
  <cp:lastModifiedBy>pe</cp:lastModifiedBy>
  <dcterms:modified xsi:type="dcterms:W3CDTF">2013-07-08T08:21:43Z</dcterms:modified>
  <cp:revision>2</cp:revision>
  <dc:subject/>
  <dc:title>Présentation PowerPoint</dc:title>
</cp:coreProperties>
</file>